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8" d="100"/>
          <a:sy n="68" d="100"/>
        </p:scale>
        <p:origin x="241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D842DAE-B771-46A1-B510-B4FEAC61F11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239B7604-3037-4C11-A22E-181E855BCB4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E63DCC31-C786-428E-923E-89EFE2CF36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90CD3-E0C1-4323-BB60-30E387D998A6}" type="datetimeFigureOut">
              <a:rPr lang="es-ES" smtClean="0"/>
              <a:t>30/09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E35B030-0C47-4E5E-B3B6-7E04284F39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39386B5-D256-4EC6-8C27-8B8D4F0DBD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D59C6-46F8-47DF-9324-177D893CB3A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061728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5738519-0EA8-44A6-9F4A-41473B8143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4300F0D4-D830-4FCC-B76E-3D5B8B96070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63D0F25-8E95-4EC4-9D22-F776222F23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90CD3-E0C1-4323-BB60-30E387D998A6}" type="datetimeFigureOut">
              <a:rPr lang="es-ES" smtClean="0"/>
              <a:t>30/09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09EDB74-1C33-43C8-9ED2-35BF76F2C6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9280AAC-E30D-42C9-8ED9-5DDAB89FF9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D59C6-46F8-47DF-9324-177D893CB3A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48477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C7B26555-9267-4039-96B9-9864017082A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BB5AD6BF-4335-4D12-A901-2E7D7A69AD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20443FF-8A2E-4601-8704-A034954995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90CD3-E0C1-4323-BB60-30E387D998A6}" type="datetimeFigureOut">
              <a:rPr lang="es-ES" smtClean="0"/>
              <a:t>30/09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C139238-4944-4105-B384-385C273AA9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DBE2035-3AF6-4427-8F96-16DA8479B0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D59C6-46F8-47DF-9324-177D893CB3A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420432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65A482B-A558-4100-B473-B0B0B45844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7123BDF7-172C-4BCD-A844-2B0E2948A65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06C43F2-55C9-4282-8603-BEEC69F3A6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90CD3-E0C1-4323-BB60-30E387D998A6}" type="datetimeFigureOut">
              <a:rPr lang="es-ES" smtClean="0"/>
              <a:t>30/09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C5D5636-E073-4BB1-919C-6193987367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BAD8308-EE46-4F1F-A680-CF0ED03088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D59C6-46F8-47DF-9324-177D893CB3A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269052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9ECB2E6-5332-44F2-B04E-E1E244F7C4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5E33FF70-029E-4896-B7C1-1137D01F407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8977B61-C682-4CFA-8CE1-D73B57658F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90CD3-E0C1-4323-BB60-30E387D998A6}" type="datetimeFigureOut">
              <a:rPr lang="es-ES" smtClean="0"/>
              <a:t>30/09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BBEA358-6E78-42A1-979F-8429BB4874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914694B-5C58-46CA-8924-4F992179D7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D59C6-46F8-47DF-9324-177D893CB3A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760759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212D356-3935-4DBC-B722-2654850477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F8973FF0-2B76-47A3-A1F2-55AAD20E4A8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DBC1D89B-FBEE-498C-962B-61B69CB95EB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3D1A96AF-EB39-4328-B9E9-098030D39F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90CD3-E0C1-4323-BB60-30E387D998A6}" type="datetimeFigureOut">
              <a:rPr lang="es-ES" smtClean="0"/>
              <a:t>30/09/2024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6B7600C5-092B-44C9-B804-401A599834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F1C92938-9BB2-49A8-AA3C-54B0CBBDC0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D59C6-46F8-47DF-9324-177D893CB3A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259629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F4E9CEC-FE0F-4020-9AE5-216CC98B7A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3690A94A-FE67-4194-B590-29CDF285F1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BF1BDD9A-FD15-4E0B-8F33-7ADB1603990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4D5DF5CD-4F28-4240-A3A2-0CF1EF487E4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FF1BDC12-A005-4E39-8C70-0A2E899180F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5AE950FF-B170-44CF-B143-A05DA6E8F8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90CD3-E0C1-4323-BB60-30E387D998A6}" type="datetimeFigureOut">
              <a:rPr lang="es-ES" smtClean="0"/>
              <a:t>30/09/2024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43B32E7A-FCD4-455D-A689-172AF0F144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E4AFF203-EADE-48E8-880F-44883C7974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D59C6-46F8-47DF-9324-177D893CB3A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341905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D2791AD-6B4D-4A1D-A50D-40E9337834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6CBB6578-86F2-438F-9407-C7B7997889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90CD3-E0C1-4323-BB60-30E387D998A6}" type="datetimeFigureOut">
              <a:rPr lang="es-ES" smtClean="0"/>
              <a:t>30/09/2024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898EF6DA-C7DA-41C1-9F18-DA54C9B30B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7F9B7C2E-90DB-44AE-92FF-75AA54C88E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D59C6-46F8-47DF-9324-177D893CB3A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139001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5DD7D11F-5425-40EE-88EF-FA549CAFD4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90CD3-E0C1-4323-BB60-30E387D998A6}" type="datetimeFigureOut">
              <a:rPr lang="es-ES" smtClean="0"/>
              <a:t>30/09/2024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DC1FC6EA-818A-4706-9556-ED964995AD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AF5CAE16-AA28-4741-883C-637CC6759B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D59C6-46F8-47DF-9324-177D893CB3A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595305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6D91329-5FCA-47DD-9E21-5D1F7B70F4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5FCD40A9-C659-40F6-B03C-D40202F12EF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8066B9BB-64D1-4055-9403-C73591E6049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E7124B5F-0A10-4341-9434-5EE7CC9793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90CD3-E0C1-4323-BB60-30E387D998A6}" type="datetimeFigureOut">
              <a:rPr lang="es-ES" smtClean="0"/>
              <a:t>30/09/2024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FCAE086A-93F9-41B3-8B9D-0D14CFC087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C61B5338-8274-452D-ABF3-10F1506A16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D59C6-46F8-47DF-9324-177D893CB3A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360633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15B494F-97A5-46BE-8D32-B4C21F34D5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562A70EE-AEC6-450B-8FF1-9356321FA46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E90C1123-B677-40AE-BCB6-3D80A1D3005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B51DC51F-767A-49F3-8A33-70209CE25A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90CD3-E0C1-4323-BB60-30E387D998A6}" type="datetimeFigureOut">
              <a:rPr lang="es-ES" smtClean="0"/>
              <a:t>30/09/2024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32955B51-1739-42C9-AC91-AA4BACD050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75F9E4B8-B07D-4830-8137-56453ED83F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D59C6-46F8-47DF-9324-177D893CB3A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770070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C06EEF93-C1D9-4216-9F25-3C4A341811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75202531-741D-4DB4-B9F6-A9B73C807B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A31E139-B0E0-4D70-B633-ECB80888568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E90CD3-E0C1-4323-BB60-30E387D998A6}" type="datetimeFigureOut">
              <a:rPr lang="es-ES" smtClean="0"/>
              <a:t>30/09/2024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DFB84263-A05B-4764-A6D6-814F833F91E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19B963D-D917-47B0-8BB3-70A807802A9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4D59C6-46F8-47DF-9324-177D893CB3A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520037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>
            <a:extLst>
              <a:ext uri="{FF2B5EF4-FFF2-40B4-BE49-F238E27FC236}">
                <a16:creationId xmlns:a16="http://schemas.microsoft.com/office/drawing/2014/main" id="{B0304EEF-01EE-4D50-B6E3-95E3DC3702F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801" t="2161" r="14893" b="65017"/>
          <a:stretch/>
        </p:blipFill>
        <p:spPr>
          <a:xfrm>
            <a:off x="1575582" y="787790"/>
            <a:ext cx="3938953" cy="2954215"/>
          </a:xfrm>
          <a:prstGeom prst="rect">
            <a:avLst/>
          </a:prstGeom>
        </p:spPr>
      </p:pic>
      <p:sp>
        <p:nvSpPr>
          <p:cNvPr id="6" name="CuadroTexto 5">
            <a:extLst>
              <a:ext uri="{FF2B5EF4-FFF2-40B4-BE49-F238E27FC236}">
                <a16:creationId xmlns:a16="http://schemas.microsoft.com/office/drawing/2014/main" id="{27AF9C55-E34A-460A-97AE-033C6E6AB5F6}"/>
              </a:ext>
            </a:extLst>
          </p:cNvPr>
          <p:cNvSpPr txBox="1"/>
          <p:nvPr/>
        </p:nvSpPr>
        <p:spPr>
          <a:xfrm>
            <a:off x="689317" y="3530991"/>
            <a:ext cx="5627077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/>
              <a:t>FIGURE </a:t>
            </a:r>
            <a:r>
              <a:rPr lang="en-US" sz="1400" dirty="0" err="1"/>
              <a:t>S1</a:t>
            </a:r>
            <a:r>
              <a:rPr lang="en-US" sz="1400" dirty="0"/>
              <a:t>. Result of immunoprecipitation of </a:t>
            </a:r>
            <a:r>
              <a:rPr lang="en-US" sz="1400" dirty="0" err="1"/>
              <a:t>AMV</a:t>
            </a:r>
            <a:r>
              <a:rPr lang="en-US" sz="1400" dirty="0"/>
              <a:t> MP analyzed by western blot. The signal obtained using the anti-HA antibody is shown. The result after (A) and before (B) immunoprecipitation is shown for the analysis of proteins obtained from tissue inoculated with the unlabeled version (control) and the </a:t>
            </a:r>
            <a:r>
              <a:rPr lang="en-US" sz="1400" dirty="0" err="1"/>
              <a:t>2HA</a:t>
            </a:r>
            <a:r>
              <a:rPr lang="en-US" sz="1400" dirty="0"/>
              <a:t> version (</a:t>
            </a:r>
            <a:r>
              <a:rPr lang="en-US" sz="1400" dirty="0" err="1"/>
              <a:t>S1</a:t>
            </a:r>
            <a:r>
              <a:rPr lang="en-US" sz="1400" dirty="0"/>
              <a:t> and </a:t>
            </a:r>
            <a:r>
              <a:rPr lang="en-US" sz="1400" dirty="0" err="1"/>
              <a:t>S2</a:t>
            </a:r>
            <a:r>
              <a:rPr lang="en-US" sz="1400" dirty="0"/>
              <a:t>). The protein size marker, expressed in </a:t>
            </a:r>
            <a:r>
              <a:rPr lang="en-US" sz="1400" dirty="0" err="1"/>
              <a:t>kDa</a:t>
            </a:r>
            <a:r>
              <a:rPr lang="en-US" sz="1400" dirty="0"/>
              <a:t>, is shown on the right of the image. Red arrows point to the specific bands of the </a:t>
            </a:r>
            <a:r>
              <a:rPr lang="en-US" sz="1400" dirty="0" err="1"/>
              <a:t>AMV</a:t>
            </a:r>
            <a:r>
              <a:rPr lang="en-US" sz="1400" dirty="0"/>
              <a:t> MP signal in the </a:t>
            </a:r>
            <a:r>
              <a:rPr lang="en-US" sz="1400" dirty="0" err="1"/>
              <a:t>immunoprecipitate</a:t>
            </a:r>
            <a:r>
              <a:rPr lang="en-US" sz="1400" dirty="0"/>
              <a:t>.</a:t>
            </a:r>
            <a:endParaRPr lang="es-ES" sz="1400" dirty="0"/>
          </a:p>
        </p:txBody>
      </p:sp>
    </p:spTree>
    <p:extLst>
      <p:ext uri="{BB962C8B-B14F-4D97-AF65-F5344CB8AC3E}">
        <p14:creationId xmlns:p14="http://schemas.microsoft.com/office/powerpoint/2010/main" val="187133970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97</Words>
  <Application>Microsoft Office PowerPoint</Application>
  <PresentationFormat>A4 (210 x 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esus Angel Sanchez Navarro</dc:creator>
  <cp:lastModifiedBy>Jesus Angel Sanchez Navarro</cp:lastModifiedBy>
  <cp:revision>1</cp:revision>
  <dcterms:created xsi:type="dcterms:W3CDTF">2024-09-30T10:40:15Z</dcterms:created>
  <dcterms:modified xsi:type="dcterms:W3CDTF">2024-09-30T10:42:17Z</dcterms:modified>
</cp:coreProperties>
</file>